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082" autoAdjust="0"/>
    <p:restoredTop sz="77000" autoAdjust="0"/>
  </p:normalViewPr>
  <p:slideViewPr>
    <p:cSldViewPr snapToGrid="0" snapToObjects="1">
      <p:cViewPr varScale="1">
        <p:scale>
          <a:sx n="63" d="100"/>
          <a:sy n="63" d="100"/>
        </p:scale>
        <p:origin x="-2172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FB776-10CD-FB47-94DC-710F9875BE93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5DAEED-EE94-604F-9056-72416A585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9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/>
              <a:t>Supplemental </a:t>
            </a:r>
            <a:r>
              <a:rPr lang="en-US" b="1" smtClean="0"/>
              <a:t>6: </a:t>
            </a:r>
            <a:r>
              <a:rPr lang="en-US" b="1" dirty="0"/>
              <a:t>Full imaging of Superhance blood flow and GFP from HCT116-GFP mice.</a:t>
            </a:r>
            <a:r>
              <a:rPr lang="en-US" b="0" dirty="0"/>
              <a:t> Representative image using </a:t>
            </a:r>
            <a:r>
              <a:rPr lang="en-US" b="0" dirty="0" err="1"/>
              <a:t>superhance</a:t>
            </a:r>
            <a:r>
              <a:rPr lang="en-US" b="0" dirty="0"/>
              <a:t> 680 probe in HCT116 xenograft bearing </a:t>
            </a:r>
            <a:r>
              <a:rPr lang="en-US" b="0" dirty="0" err="1"/>
              <a:t>athymic</a:t>
            </a:r>
            <a:r>
              <a:rPr lang="en-US" b="0" dirty="0"/>
              <a:t> nude mice after 4 weeks. </a:t>
            </a:r>
            <a:r>
              <a:rPr lang="en-US" altLang="en-US" dirty="0"/>
              <a:t>ONC201: 50mg/kg every week. Regorafenib: 5mg/kg daily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vacizumab</a:t>
            </a:r>
            <a:r>
              <a:rPr lang="en-US" altLang="en-US" dirty="0"/>
              <a:t>: 5mg/kg every other week. N=5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34B4C1-4FF2-4F6E-AD9F-C3425F53B08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69665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15B7B-69FE-D941-9EAE-512165C8B66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592CB-360B-4F44-892B-C72929B4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638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18" Type="http://schemas.openxmlformats.org/officeDocument/2006/relationships/image" Target="../media/image16.jpg"/><Relationship Id="rId26" Type="http://schemas.openxmlformats.org/officeDocument/2006/relationships/image" Target="../media/image24.jpeg"/><Relationship Id="rId3" Type="http://schemas.openxmlformats.org/officeDocument/2006/relationships/image" Target="../media/image1.png"/><Relationship Id="rId21" Type="http://schemas.openxmlformats.org/officeDocument/2006/relationships/image" Target="../media/image19.jpe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17" Type="http://schemas.openxmlformats.org/officeDocument/2006/relationships/image" Target="../media/image15.jp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24" Type="http://schemas.openxmlformats.org/officeDocument/2006/relationships/image" Target="../media/image22.jpeg"/><Relationship Id="rId32" Type="http://schemas.openxmlformats.org/officeDocument/2006/relationships/image" Target="../media/image30.jpeg"/><Relationship Id="rId5" Type="http://schemas.openxmlformats.org/officeDocument/2006/relationships/image" Target="../media/image3.jpg"/><Relationship Id="rId15" Type="http://schemas.openxmlformats.org/officeDocument/2006/relationships/image" Target="../media/image13.jp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g"/><Relationship Id="rId19" Type="http://schemas.openxmlformats.org/officeDocument/2006/relationships/image" Target="../media/image17.jpg"/><Relationship Id="rId31" Type="http://schemas.openxmlformats.org/officeDocument/2006/relationships/image" Target="../media/image29.jpe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pn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4B313C49-CDC0-45B0-9B7A-409BDEEC6DEB}"/>
              </a:ext>
            </a:extLst>
          </p:cNvPr>
          <p:cNvSpPr txBox="1"/>
          <p:nvPr/>
        </p:nvSpPr>
        <p:spPr>
          <a:xfrm>
            <a:off x="0" y="8686453"/>
            <a:ext cx="4008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agner </a:t>
            </a:r>
            <a:r>
              <a:rPr lang="en-US" b="1" i="1" dirty="0"/>
              <a:t>et al</a:t>
            </a:r>
            <a:r>
              <a:rPr lang="en-US" b="1" dirty="0"/>
              <a:t>., Supplemental Figure </a:t>
            </a:r>
            <a:r>
              <a:rPr lang="en-US" b="1" dirty="0" smtClean="0"/>
              <a:t>6</a:t>
            </a:r>
            <a:endParaRPr lang="en-US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CBF52FCB-9930-4FA9-AC3F-026B46488333}"/>
              </a:ext>
            </a:extLst>
          </p:cNvPr>
          <p:cNvGrpSpPr/>
          <p:nvPr/>
        </p:nvGrpSpPr>
        <p:grpSpPr>
          <a:xfrm>
            <a:off x="-27817" y="49582"/>
            <a:ext cx="3646508" cy="6772377"/>
            <a:chOff x="-27817" y="49582"/>
            <a:chExt cx="3646508" cy="677237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202ED196-45D4-43B4-9D3A-EF49828A9338}"/>
                </a:ext>
              </a:extLst>
            </p:cNvPr>
            <p:cNvSpPr txBox="1"/>
            <p:nvPr/>
          </p:nvSpPr>
          <p:spPr>
            <a:xfrm rot="16200000">
              <a:off x="-90998" y="1185611"/>
              <a:ext cx="11786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Vehicl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FC46CC0E-67A8-41C7-91C7-4E65A9D090AF}"/>
                </a:ext>
              </a:extLst>
            </p:cNvPr>
            <p:cNvSpPr txBox="1"/>
            <p:nvPr/>
          </p:nvSpPr>
          <p:spPr>
            <a:xfrm rot="16200000">
              <a:off x="-98255" y="2161729"/>
              <a:ext cx="115479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ONC20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ADD193E7-ABE8-4349-9E64-6C64B01E89A0}"/>
                </a:ext>
              </a:extLst>
            </p:cNvPr>
            <p:cNvSpPr txBox="1"/>
            <p:nvPr/>
          </p:nvSpPr>
          <p:spPr>
            <a:xfrm rot="16200000">
              <a:off x="-79274" y="2824560"/>
              <a:ext cx="1154793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 err="1"/>
                <a:t>Bevaciz-umab</a:t>
              </a:r>
              <a:endParaRPr lang="en-US" sz="2000" dirty="0"/>
            </a:p>
            <a:p>
              <a:endParaRPr lang="en-US" sz="20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23BD1600-7FCE-4C37-888E-16E7025BF2DD}"/>
                </a:ext>
              </a:extLst>
            </p:cNvPr>
            <p:cNvSpPr txBox="1"/>
            <p:nvPr/>
          </p:nvSpPr>
          <p:spPr>
            <a:xfrm rot="16200000">
              <a:off x="-248371" y="3946041"/>
              <a:ext cx="115479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ONC201 + Bev.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D0D76216-5DC8-45D2-85D7-D81D4649077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8365" y="2058117"/>
              <a:ext cx="914400" cy="9144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DB12D6E2-1907-42A8-B125-C1BF2660BD1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527" y="2058117"/>
              <a:ext cx="914400" cy="9144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E841493E-8D20-4699-ADF8-9489A03D9AC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1446" y="2058117"/>
              <a:ext cx="914400" cy="9144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98BB7C05-2FDF-42ED-B4F7-17DC025A432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8365" y="3996321"/>
              <a:ext cx="914400" cy="9144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47907A20-118C-4438-8E22-3E765B64E5D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7252" y="4000027"/>
              <a:ext cx="914400" cy="9144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0AF6F606-60ED-4742-A28E-9542F14B994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743" y="4001710"/>
              <a:ext cx="914400" cy="9144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B36DD6CB-7B7E-4C3A-9463-4D694E99DA8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743" y="3028729"/>
              <a:ext cx="914400" cy="9144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3B6AD195-F1A7-429C-9498-E15BBF7ADF8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7252" y="3028729"/>
              <a:ext cx="914400" cy="9144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0BE13D4B-E5D6-4993-94E3-E7FBC5110D0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9586" y="3042132"/>
              <a:ext cx="914400" cy="9144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9488CFDC-93AD-4C55-B047-40877066263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743" y="1087505"/>
              <a:ext cx="914400" cy="9144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xmlns="" id="{E0C740E7-A305-49EC-BAC7-358D0633615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7252" y="1087505"/>
              <a:ext cx="914400" cy="9144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F96BE9FD-D5E1-4040-85CD-AC07F0E5821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9977" y="1093905"/>
              <a:ext cx="914400" cy="9144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xmlns="" id="{0191F3C5-55DC-4A26-A99A-0FA2E6F26D7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743" y="4945993"/>
              <a:ext cx="914400" cy="91440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xmlns="" id="{D04020E9-CDB5-4521-AD22-E8ACB5747FD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9977" y="4950510"/>
              <a:ext cx="914400" cy="91440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xmlns="" id="{377D821F-2934-4F81-9933-E52CC8CF026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7252" y="4945993"/>
              <a:ext cx="914400" cy="91440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xmlns="" id="{5F067A19-FD9D-4C0A-B1C3-1D3BD4ACC41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527" y="5907559"/>
              <a:ext cx="914400" cy="91440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xmlns="" id="{B0A7DE01-B592-448C-B690-783EEDE52C2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7252" y="5901280"/>
              <a:ext cx="914400" cy="914400"/>
            </a:xfrm>
            <a:prstGeom prst="rect">
              <a:avLst/>
            </a:prstGeom>
          </p:spPr>
        </p:pic>
        <p:pic>
          <p:nvPicPr>
            <p:cNvPr id="28" name="Picture 3">
              <a:extLst>
                <a:ext uri="{FF2B5EF4-FFF2-40B4-BE49-F238E27FC236}">
                  <a16:creationId xmlns:a16="http://schemas.microsoft.com/office/drawing/2014/main" xmlns="" id="{B0F258B7-BC28-43FB-BE04-0F646DF22343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619977" y="5901280"/>
              <a:ext cx="914400" cy="914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1E53CBC2-77A1-46B2-9566-D25CBF51571E}"/>
                </a:ext>
              </a:extLst>
            </p:cNvPr>
            <p:cNvSpPr txBox="1"/>
            <p:nvPr/>
          </p:nvSpPr>
          <p:spPr>
            <a:xfrm rot="16200000">
              <a:off x="-215335" y="4931653"/>
              <a:ext cx="1082921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 err="1"/>
                <a:t>Regoraf-inib</a:t>
              </a:r>
              <a:endParaRPr lang="en-US" sz="20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3CE597A4-826C-43BB-8143-6F8DEFE3766B}"/>
                </a:ext>
              </a:extLst>
            </p:cNvPr>
            <p:cNvSpPr txBox="1"/>
            <p:nvPr/>
          </p:nvSpPr>
          <p:spPr>
            <a:xfrm rot="16200000">
              <a:off x="-248760" y="5851000"/>
              <a:ext cx="115479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ONC201 + </a:t>
              </a:r>
              <a:r>
                <a:rPr lang="en-US" sz="2000" dirty="0" err="1"/>
                <a:t>Regor</a:t>
              </a:r>
              <a:r>
                <a:rPr lang="en-US" sz="2000" dirty="0"/>
                <a:t>.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5F677E04-F675-4ABF-A801-3390ED5F2B5D}"/>
                </a:ext>
              </a:extLst>
            </p:cNvPr>
            <p:cNvSpPr txBox="1"/>
            <p:nvPr/>
          </p:nvSpPr>
          <p:spPr>
            <a:xfrm>
              <a:off x="631315" y="372808"/>
              <a:ext cx="997612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Blood Flow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9244507E-990C-4723-8D2D-718A591A1D05}"/>
                </a:ext>
              </a:extLst>
            </p:cNvPr>
            <p:cNvSpPr txBox="1"/>
            <p:nvPr/>
          </p:nvSpPr>
          <p:spPr>
            <a:xfrm>
              <a:off x="1628927" y="372807"/>
              <a:ext cx="100004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GFP-Tumor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6C2FA896-6413-41E1-AB58-DDB0C6AAFF30}"/>
                </a:ext>
              </a:extLst>
            </p:cNvPr>
            <p:cNvSpPr txBox="1"/>
            <p:nvPr/>
          </p:nvSpPr>
          <p:spPr>
            <a:xfrm>
              <a:off x="701743" y="49582"/>
              <a:ext cx="29169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/>
                <a:t>HCT116-GFP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53B8FE3D-48A2-4F11-B6EA-B8B420B38D47}"/>
                </a:ext>
              </a:extLst>
            </p:cNvPr>
            <p:cNvSpPr txBox="1"/>
            <p:nvPr/>
          </p:nvSpPr>
          <p:spPr>
            <a:xfrm>
              <a:off x="2524295" y="378535"/>
              <a:ext cx="100004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/>
                <a:t>Light Image</a:t>
              </a:r>
            </a:p>
          </p:txBody>
        </p:sp>
      </p:grpSp>
      <p:pic>
        <p:nvPicPr>
          <p:cNvPr id="35" name="Picture 34">
            <a:extLst>
              <a:ext uri="{FF2B5EF4-FFF2-40B4-BE49-F238E27FC236}">
                <a16:creationId xmlns:a16="http://schemas.microsoft.com/office/drawing/2014/main" xmlns="" id="{51B4F0CE-0C28-422A-87F2-AD97C0AE9FE1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61065" y="2928315"/>
            <a:ext cx="1004887" cy="1002267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AC4D3D91-EAFF-4392-8516-FD48FAA4BD82}"/>
              </a:ext>
            </a:extLst>
          </p:cNvPr>
          <p:cNvSpPr txBox="1"/>
          <p:nvPr/>
        </p:nvSpPr>
        <p:spPr>
          <a:xfrm rot="16200000">
            <a:off x="3455239" y="1077044"/>
            <a:ext cx="10022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ehicl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92A1C69-E2E8-4FE9-B9C1-78DCBF9814B9}"/>
              </a:ext>
            </a:extLst>
          </p:cNvPr>
          <p:cNvSpPr txBox="1"/>
          <p:nvPr/>
        </p:nvSpPr>
        <p:spPr>
          <a:xfrm rot="16200000">
            <a:off x="3378977" y="2074040"/>
            <a:ext cx="11547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ONC20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5F2BDD73-27B4-4230-AFAE-BD61C311AD53}"/>
              </a:ext>
            </a:extLst>
          </p:cNvPr>
          <p:cNvSpPr txBox="1"/>
          <p:nvPr/>
        </p:nvSpPr>
        <p:spPr>
          <a:xfrm rot="16200000">
            <a:off x="3267347" y="4118100"/>
            <a:ext cx="108292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Bev. +</a:t>
            </a:r>
          </a:p>
          <a:p>
            <a:pPr algn="ctr"/>
            <a:r>
              <a:rPr lang="en-US" sz="2000" dirty="0"/>
              <a:t>ONC201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xmlns="" id="{8091C4E2-9006-4CAC-B9E5-1384506DFF07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74857" y="775966"/>
            <a:ext cx="1009650" cy="100226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xmlns="" id="{A26C02F4-7E90-4F6E-B10D-5DC91BF5C7D1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18325" y="775966"/>
            <a:ext cx="1009650" cy="1002267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xmlns="" id="{566AA1FE-22FB-4443-BFB6-1C25FFA5EE65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08228" y="2928314"/>
            <a:ext cx="1004887" cy="1002267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xmlns="" id="{C19D6E64-0B3B-4829-AD2A-99D68E3136C4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67582" y="5090049"/>
            <a:ext cx="1004887" cy="100488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xmlns="" id="{4D1CCF3F-9A8D-42ED-B3A0-F5014D3EC125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391634" y="5090049"/>
            <a:ext cx="1004887" cy="1004888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xmlns="" id="{8EB2E150-A15D-4866-9970-F9649C9D09B4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61065" y="1846604"/>
            <a:ext cx="1007216" cy="100488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xmlns="" id="{09BE5C1C-8DCC-4A18-A1EE-EE108A90D978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08228" y="1846603"/>
            <a:ext cx="1007216" cy="1004888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xmlns="" id="{1B1F69A3-AAC3-44AC-8C36-8A457EE13944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57656" y="6171484"/>
            <a:ext cx="1008296" cy="1007458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xmlns="" id="{328F4534-C1CE-4BC9-8316-9E1D98CDF0DE}"/>
              </a:ext>
            </a:extLst>
          </p:cNvPr>
          <p:cNvPicPr>
            <a:picLocks noChangeAspect="1"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391634" y="6184573"/>
            <a:ext cx="1007458" cy="1007458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463588E6-23E7-40FF-86D5-970D83A1C9A1}"/>
              </a:ext>
            </a:extLst>
          </p:cNvPr>
          <p:cNvSpPr txBox="1"/>
          <p:nvPr/>
        </p:nvSpPr>
        <p:spPr>
          <a:xfrm rot="16200000">
            <a:off x="3356180" y="5276957"/>
            <a:ext cx="9233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err="1"/>
              <a:t>Regora-finib</a:t>
            </a:r>
            <a:endParaRPr lang="en-US" sz="20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E78A6CCE-74F1-43CC-8240-8A6C87DB91E5}"/>
              </a:ext>
            </a:extLst>
          </p:cNvPr>
          <p:cNvSpPr txBox="1"/>
          <p:nvPr/>
        </p:nvSpPr>
        <p:spPr>
          <a:xfrm rot="16200000">
            <a:off x="3244451" y="6260640"/>
            <a:ext cx="112871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err="1"/>
              <a:t>Regor</a:t>
            </a:r>
            <a:r>
              <a:rPr lang="en-US" sz="2000" dirty="0"/>
              <a:t>.+ ONC20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D25633C4-F525-4620-92E2-2B2170AB1DCE}"/>
              </a:ext>
            </a:extLst>
          </p:cNvPr>
          <p:cNvSpPr txBox="1"/>
          <p:nvPr/>
        </p:nvSpPr>
        <p:spPr>
          <a:xfrm rot="16200000">
            <a:off x="3428322" y="3063134"/>
            <a:ext cx="102700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err="1"/>
              <a:t>Bevaciz-umab</a:t>
            </a:r>
            <a:endParaRPr lang="en-US" sz="2000" dirty="0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xmlns="" id="{89A14CF7-30A5-49C4-98AA-BD1FE29E4952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08228" y="3996383"/>
            <a:ext cx="1003109" cy="100403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xmlns="" id="{6A50C188-19AA-450E-BBAF-DE90F3D9AA6B}"/>
              </a:ext>
            </a:extLst>
          </p:cNvPr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69360" y="4009473"/>
            <a:ext cx="1003109" cy="1004030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4EBEFD0D-8538-42E1-A509-C947509B1335}"/>
              </a:ext>
            </a:extLst>
          </p:cNvPr>
          <p:cNvSpPr txBox="1"/>
          <p:nvPr/>
        </p:nvSpPr>
        <p:spPr>
          <a:xfrm>
            <a:off x="3896492" y="336410"/>
            <a:ext cx="15218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Blood Flow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CF36BF06-5905-4B8B-AB29-7D6C2609BADB}"/>
              </a:ext>
            </a:extLst>
          </p:cNvPr>
          <p:cNvSpPr txBox="1"/>
          <p:nvPr/>
        </p:nvSpPr>
        <p:spPr>
          <a:xfrm>
            <a:off x="5217588" y="336757"/>
            <a:ext cx="1585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GFP-Tumor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1DB59429-479E-499C-9736-3178918730F0}"/>
              </a:ext>
            </a:extLst>
          </p:cNvPr>
          <p:cNvSpPr txBox="1"/>
          <p:nvPr/>
        </p:nvSpPr>
        <p:spPr>
          <a:xfrm>
            <a:off x="4257656" y="-58678"/>
            <a:ext cx="22777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HCT116-GFP</a:t>
            </a:r>
          </a:p>
        </p:txBody>
      </p:sp>
    </p:spTree>
    <p:extLst>
      <p:ext uri="{BB962C8B-B14F-4D97-AF65-F5344CB8AC3E}">
        <p14:creationId xmlns:p14="http://schemas.microsoft.com/office/powerpoint/2010/main" val="1361587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</TotalTime>
  <Words>92</Words>
  <Application>Microsoft Office PowerPoint</Application>
  <PresentationFormat>Letter Paper (8.5x11 in)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omoza, Jesun</cp:lastModifiedBy>
  <cp:revision>21</cp:revision>
  <dcterms:created xsi:type="dcterms:W3CDTF">2017-08-21T16:00:13Z</dcterms:created>
  <dcterms:modified xsi:type="dcterms:W3CDTF">2018-01-20T13:54:33Z</dcterms:modified>
</cp:coreProperties>
</file>